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6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송재진(의생명과학부)" initials="송" lastIdx="0" clrIdx="0">
    <p:extLst>
      <p:ext uri="{19B8F6BF-5375-455C-9EA6-DF929625EA0E}">
        <p15:presenceInfo xmlns:p15="http://schemas.microsoft.com/office/powerpoint/2012/main" userId="S-1-5-21-1961260681-1744463731-1174482739-5253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25" autoAdjust="0"/>
    <p:restoredTop sz="96754" autoAdjust="0"/>
  </p:normalViewPr>
  <p:slideViewPr>
    <p:cSldViewPr>
      <p:cViewPr varScale="1">
        <p:scale>
          <a:sx n="84" d="100"/>
          <a:sy n="84" d="100"/>
        </p:scale>
        <p:origin x="3594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75" d="100"/>
          <a:sy n="75" d="100"/>
        </p:scale>
        <p:origin x="-2238" y="-96"/>
      </p:cViewPr>
      <p:guideLst>
        <p:guide orient="horz" pos="3126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7B5297-8AF9-4662-8439-A42EEAB29B89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1FB9AF-191C-4A97-901B-B76D64413D3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48605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91B20B3F-015D-4D5C-8145-BEDC1A5A80D2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97F86E4C-FF9F-40A3-A151-3E4B9A7E95E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3350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10" Type="http://schemas.openxmlformats.org/officeDocument/2006/relationships/image" Target="../media/image6.png"/><Relationship Id="rId4" Type="http://schemas.openxmlformats.org/officeDocument/2006/relationships/image" Target="../media/image2.jpg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9" name="TextBox 1168"/>
          <p:cNvSpPr txBox="1"/>
          <p:nvPr/>
        </p:nvSpPr>
        <p:spPr>
          <a:xfrm>
            <a:off x="112873" y="269980"/>
            <a:ext cx="2173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0" name="TextBox 1"/>
          <p:cNvSpPr txBox="1"/>
          <p:nvPr/>
        </p:nvSpPr>
        <p:spPr>
          <a:xfrm rot="19219596">
            <a:off x="1077508" y="2031577"/>
            <a:ext cx="524706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BNL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1" name="직사각형 1170"/>
          <p:cNvSpPr/>
          <p:nvPr/>
        </p:nvSpPr>
        <p:spPr>
          <a:xfrm>
            <a:off x="498375" y="2384673"/>
            <a:ext cx="531798" cy="246221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stat3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2" name="직사각형 1171"/>
          <p:cNvSpPr/>
          <p:nvPr/>
        </p:nvSpPr>
        <p:spPr>
          <a:xfrm>
            <a:off x="404664" y="2715296"/>
            <a:ext cx="674018" cy="246221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HSP25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3" name="직사각형 1172"/>
          <p:cNvSpPr/>
          <p:nvPr/>
        </p:nvSpPr>
        <p:spPr>
          <a:xfrm>
            <a:off x="427747" y="3451188"/>
            <a:ext cx="627853" cy="246221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HSP25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4" name="직사각형 1173"/>
          <p:cNvSpPr/>
          <p:nvPr/>
        </p:nvSpPr>
        <p:spPr>
          <a:xfrm>
            <a:off x="1379055" y="4031349"/>
            <a:ext cx="582911" cy="2308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lysate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5" name="직사각형 1174"/>
          <p:cNvSpPr/>
          <p:nvPr/>
        </p:nvSpPr>
        <p:spPr>
          <a:xfrm>
            <a:off x="1207691" y="3065994"/>
            <a:ext cx="792088" cy="230832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ko-KR" sz="900" b="1" dirty="0" smtClean="0">
                <a:latin typeface="Arial" pitchFamily="34" charset="0"/>
                <a:cs typeface="Arial" pitchFamily="34" charset="0"/>
              </a:rPr>
              <a:t>IP: HSP25</a:t>
            </a:r>
            <a:endParaRPr lang="ko-KR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6" name="직사각형 1175"/>
          <p:cNvSpPr/>
          <p:nvPr/>
        </p:nvSpPr>
        <p:spPr>
          <a:xfrm>
            <a:off x="492920" y="3768302"/>
            <a:ext cx="497505" cy="246221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stat3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77" name="TextBox 1176">
            <a:extLst>
              <a:ext uri="{FF2B5EF4-FFF2-40B4-BE49-F238E27FC236}">
                <a16:creationId xmlns:a16="http://schemas.microsoft.com/office/drawing/2014/main" id="{320A4B30-2607-488B-AFF6-C7D9FDF1A524}"/>
              </a:ext>
            </a:extLst>
          </p:cNvPr>
          <p:cNvSpPr txBox="1"/>
          <p:nvPr/>
        </p:nvSpPr>
        <p:spPr>
          <a:xfrm rot="19262352">
            <a:off x="1434908" y="1916717"/>
            <a:ext cx="8666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NL-HSP25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8" name="TextBox 1177">
            <a:extLst>
              <a:ext uri="{FF2B5EF4-FFF2-40B4-BE49-F238E27FC236}">
                <a16:creationId xmlns:a16="http://schemas.microsoft.com/office/drawing/2014/main" id="{320A4B30-2607-488B-AFF6-C7D9FDF1A524}"/>
              </a:ext>
            </a:extLst>
          </p:cNvPr>
          <p:cNvSpPr txBox="1"/>
          <p:nvPr/>
        </p:nvSpPr>
        <p:spPr>
          <a:xfrm rot="19262352">
            <a:off x="1738253" y="1795416"/>
            <a:ext cx="13277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NL-HSP25/27 I+II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79" name="그림 1178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827" t="36674" r="23113" b="55061"/>
          <a:stretch/>
        </p:blipFill>
        <p:spPr>
          <a:xfrm>
            <a:off x="1018466" y="3738489"/>
            <a:ext cx="1211590" cy="2802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80" name="그림 117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27" t="51004" r="22924" b="43127"/>
          <a:stretch/>
        </p:blipFill>
        <p:spPr>
          <a:xfrm>
            <a:off x="1017613" y="3450456"/>
            <a:ext cx="1212355" cy="2516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81" name="TextBox 1180"/>
          <p:cNvSpPr txBox="1"/>
          <p:nvPr/>
        </p:nvSpPr>
        <p:spPr>
          <a:xfrm>
            <a:off x="3330130" y="14036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82" name="그림 1181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027" t="49283" r="55283" b="41977"/>
          <a:stretch/>
        </p:blipFill>
        <p:spPr>
          <a:xfrm>
            <a:off x="1017613" y="2713339"/>
            <a:ext cx="1212355" cy="29310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83" name="그림 1182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473" t="30416" r="55943" b="62061"/>
          <a:stretch/>
        </p:blipFill>
        <p:spPr>
          <a:xfrm>
            <a:off x="1008081" y="2383115"/>
            <a:ext cx="1231417" cy="2845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84" name="TextBox 1183"/>
          <p:cNvSpPr txBox="1"/>
          <p:nvPr/>
        </p:nvSpPr>
        <p:spPr>
          <a:xfrm>
            <a:off x="4930138" y="1377405"/>
            <a:ext cx="369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85" name="그룹 1184"/>
          <p:cNvGrpSpPr/>
          <p:nvPr/>
        </p:nvGrpSpPr>
        <p:grpSpPr>
          <a:xfrm>
            <a:off x="5299938" y="1752701"/>
            <a:ext cx="1501756" cy="1648636"/>
            <a:chOff x="542925" y="1196752"/>
            <a:chExt cx="4029075" cy="2745489"/>
          </a:xfrm>
        </p:grpSpPr>
        <p:pic>
          <p:nvPicPr>
            <p:cNvPr id="1186" name="Picture 2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578" b="27175"/>
            <a:stretch/>
          </p:blipFill>
          <p:spPr bwMode="auto">
            <a:xfrm>
              <a:off x="542925" y="1196752"/>
              <a:ext cx="4029075" cy="22322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87" name="TextBox 1186"/>
            <p:cNvSpPr txBox="1"/>
            <p:nvPr/>
          </p:nvSpPr>
          <p:spPr>
            <a:xfrm rot="18912256">
              <a:off x="1030168" y="3579785"/>
              <a:ext cx="1331316" cy="285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cDNA3.1</a:t>
              </a:r>
              <a:endParaRPr lang="ko-KR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8" name="TextBox 1187"/>
            <p:cNvSpPr txBox="1"/>
            <p:nvPr/>
          </p:nvSpPr>
          <p:spPr>
            <a:xfrm rot="18912256">
              <a:off x="2009553" y="3518976"/>
              <a:ext cx="1040381" cy="285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25</a:t>
              </a:r>
              <a:endParaRPr lang="ko-KR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9" name="TextBox 1188"/>
            <p:cNvSpPr txBox="1"/>
            <p:nvPr/>
          </p:nvSpPr>
          <p:spPr>
            <a:xfrm rot="18912256">
              <a:off x="2196930" y="3656599"/>
              <a:ext cx="1610612" cy="2856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25/27 I+II</a:t>
              </a:r>
              <a:endParaRPr lang="ko-KR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0" name="TextBox 1189"/>
            <p:cNvSpPr txBox="1"/>
            <p:nvPr/>
          </p:nvSpPr>
          <p:spPr>
            <a:xfrm rot="18912256">
              <a:off x="3448260" y="3513864"/>
              <a:ext cx="1040382" cy="2856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27</a:t>
              </a:r>
              <a:endParaRPr lang="ko-KR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91" name="그룹 1190"/>
          <p:cNvGrpSpPr/>
          <p:nvPr/>
        </p:nvGrpSpPr>
        <p:grpSpPr>
          <a:xfrm>
            <a:off x="3309855" y="1953131"/>
            <a:ext cx="1506773" cy="1497325"/>
            <a:chOff x="899591" y="1340768"/>
            <a:chExt cx="3096345" cy="2559717"/>
          </a:xfrm>
        </p:grpSpPr>
        <p:pic>
          <p:nvPicPr>
            <p:cNvPr id="1192" name="Picture 2"/>
            <p:cNvPicPr>
              <a:picLocks noChangeAspect="1" noChangeArrowheads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393" b="27707"/>
            <a:stretch/>
          </p:blipFill>
          <p:spPr bwMode="auto">
            <a:xfrm>
              <a:off x="899591" y="1340768"/>
              <a:ext cx="3096345" cy="20882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93" name="TextBox 1192"/>
            <p:cNvSpPr txBox="1"/>
            <p:nvPr/>
          </p:nvSpPr>
          <p:spPr>
            <a:xfrm rot="18912256">
              <a:off x="1228677" y="3593382"/>
              <a:ext cx="1130533" cy="2772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cDNA3.1</a:t>
              </a:r>
              <a:endParaRPr lang="ko-KR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4" name="TextBox 1193"/>
            <p:cNvSpPr txBox="1"/>
            <p:nvPr/>
          </p:nvSpPr>
          <p:spPr>
            <a:xfrm rot="18912256">
              <a:off x="2152698" y="3500283"/>
              <a:ext cx="883477" cy="2772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25</a:t>
              </a:r>
              <a:endParaRPr lang="ko-KR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5" name="TextBox 1194"/>
            <p:cNvSpPr txBox="1"/>
            <p:nvPr/>
          </p:nvSpPr>
          <p:spPr>
            <a:xfrm rot="18912256">
              <a:off x="2516772" y="3623246"/>
              <a:ext cx="1367708" cy="2772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25/27 I+II</a:t>
              </a:r>
              <a:endParaRPr lang="ko-KR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96" name="TextBox 1195"/>
          <p:cNvSpPr txBox="1"/>
          <p:nvPr/>
        </p:nvSpPr>
        <p:spPr>
          <a:xfrm>
            <a:off x="351371" y="14036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81</TotalTime>
  <Words>27</Words>
  <Application>Microsoft Office PowerPoint</Application>
  <PresentationFormat>화면 슬라이드 쇼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severan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1522</cp:revision>
  <cp:lastPrinted>2019-05-07T06:31:19Z</cp:lastPrinted>
  <dcterms:created xsi:type="dcterms:W3CDTF">2016-01-12T05:31:29Z</dcterms:created>
  <dcterms:modified xsi:type="dcterms:W3CDTF">2019-05-29T08:08:36Z</dcterms:modified>
</cp:coreProperties>
</file>